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  <p:sldId id="278" r:id="rId3"/>
    <p:sldId id="257" r:id="rId4"/>
    <p:sldId id="280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06700"/>
    <a:srgbClr val="AA5909"/>
    <a:srgbClr val="3AFDFD"/>
    <a:srgbClr val="C76300"/>
    <a:srgbClr val="FFB34B"/>
    <a:srgbClr val="9DFE9C"/>
    <a:srgbClr val="C3FEC3"/>
    <a:srgbClr val="AF6216"/>
    <a:srgbClr val="CB6602"/>
    <a:srgbClr val="FAA6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69" autoAdjust="0"/>
    <p:restoredTop sz="94660"/>
  </p:normalViewPr>
  <p:slideViewPr>
    <p:cSldViewPr snapToGrid="0">
      <p:cViewPr varScale="1">
        <p:scale>
          <a:sx n="82" d="100"/>
          <a:sy n="82" d="100"/>
        </p:scale>
        <p:origin x="8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BD82029-CE90-AE5F-75B1-279099AA79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CB09BCF-27EF-8063-8F16-9D11EC3275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1839A0D-E45B-7872-01B9-8C6B591AE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E353B-6FAA-41A0-9677-81D242CA94D0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E404509-9ADB-5B05-8522-3BA5FACF0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2790C40-DF59-9A0D-2C35-2BC469823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AD7AD-0B9D-4B31-AA14-A6AB9F97C39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318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3169A00-2546-581C-56D9-0F250CE2E7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BFB694D-AB2B-A4E3-1F00-D91780B686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974374B-7C20-DBA9-79D0-81E6C14238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E353B-6FAA-41A0-9677-81D242CA94D0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0F73C49-4F83-B483-4DEF-9060D6E8FE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9E79115-30F5-86F0-FA06-A7DBA58FE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AD7AD-0B9D-4B31-AA14-A6AB9F97C39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116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0E13AB1D-81EC-0DCA-DDF4-12F28B10C1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03CBD1B-06E1-E08C-96EC-B39F7DA793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0C005E3-99B9-C84F-1EA8-12F787D5A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E353B-6FAA-41A0-9677-81D242CA94D0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4F8FD6A-0701-B2CB-3D18-9E3F4C8096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1653BA6-DC9C-14A2-8C10-6E35E0D15D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AD7AD-0B9D-4B31-AA14-A6AB9F97C39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20856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 and 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609585" lvl="0" indent="-457189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1219170" lvl="1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828754" lvl="2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2438339" lvl="3" indent="-423323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3047924" lvl="4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3657509" lvl="5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4267093" lvl="6" indent="-423323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4876678" lvl="7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5486263" lvl="8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fr-BE" smtClean="0"/>
              <a:pPr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571005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2667191-6D08-48A9-82DE-9B1978AA07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B732B34-EA85-3741-879C-EFA0AB874B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150D84E-DCEE-18C0-796B-BF766E2C2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E353B-6FAA-41A0-9677-81D242CA94D0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B3AE457-FC3F-1FF8-DC6D-F66A8D411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9DF4F91-5FF5-6686-5896-FF55E0C658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AD7AD-0B9D-4B31-AA14-A6AB9F97C39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222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3D61CC-CB7E-04DE-40AC-870470AA78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7CB3A83-7100-44BD-4456-966C905C6D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E235E09-37D3-CCF1-DF61-906693C4C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E353B-6FAA-41A0-9677-81D242CA94D0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EF02F3A-8FFB-93FA-D9C9-8F2E3D4F8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82B3635-9D07-2F3E-B5CD-1F8A9426A2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AD7AD-0B9D-4B31-AA14-A6AB9F97C39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247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0B7ECE0-7781-74E1-F110-C9FB0AF305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1B16FE4-EEF6-1481-7CAC-E35D387C7A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09F9F3E-0E52-CB15-4B7A-A24F080249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C96319F-27D6-6C93-7B15-394E747157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E353B-6FAA-41A0-9677-81D242CA94D0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7EA1F67-DCBE-AF80-96DD-B1FEBB72DF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C69B2F9-E079-C0E1-6512-F58FD8F2F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AD7AD-0B9D-4B31-AA14-A6AB9F97C39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556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52F8810-1DA3-2564-F672-5DFD93A4F4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2DB67AA-9414-D8AD-A232-77825AFEE5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98DA5B8-588D-E614-829C-C2D6BC4765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D42D6BF-2A2D-4C23-E879-55DA29232D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F7B08DA-179A-1F01-8E1B-B86D733B5E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B91DCF6-319B-5E92-6421-F3E325AB2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E353B-6FAA-41A0-9677-81D242CA94D0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3260F7F-DED7-763B-0F3A-8FF174A80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5E16ED99-FA8B-104C-123B-879BABD98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AD7AD-0B9D-4B31-AA14-A6AB9F97C39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396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4E48598-9364-A407-7B66-D696657919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47C0748D-EAFC-76AF-47D7-C2109F24C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E353B-6FAA-41A0-9677-81D242CA94D0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DC8F61A9-A767-A556-4C7F-1EBE38810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0D6BF1B1-86CD-510B-83DD-6470D334FD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AD7AD-0B9D-4B31-AA14-A6AB9F97C39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061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28C233EA-B812-F4B8-B26A-0186B909AA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E353B-6FAA-41A0-9677-81D242CA94D0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A48FC8CF-4B52-AF6D-11DC-A6CFE64D3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83427701-C397-0C17-BAFF-8483C90E9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AD7AD-0B9D-4B31-AA14-A6AB9F97C39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577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FFB5946-9D26-AE19-4E5E-3D17A93D07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58562E3-B727-E217-4D3F-700EF49E4F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0B0C5C3-32DE-DF92-2901-8C9FC5B995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5E69332-279E-57CC-471E-C04493881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E353B-6FAA-41A0-9677-81D242CA94D0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553FCCB-56EA-5DC3-94AC-7DAB5D0323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5E1AF01-87A1-1015-E491-D8A3F0A30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AD7AD-0B9D-4B31-AA14-A6AB9F97C39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70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8D437C5-2AE9-AB43-170A-11475F0B3E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0409041E-801D-18C0-F4A2-FA476255FF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A4E983C-D840-D39D-C446-9D2F9F833D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9272DD7-3D1F-A90C-2E7F-DEC8825654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E353B-6FAA-41A0-9677-81D242CA94D0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F2B9653-90A5-70E2-7682-00B191F5B7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926AE45-41E9-72FB-85EE-71BD0C8DE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AD7AD-0B9D-4B31-AA14-A6AB9F97C39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764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6C68C4DE-0D39-2F31-10A9-B944F57C38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8A13A5E-89F6-A378-39DF-A28021E3B9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B94E4D4-82CA-233A-FAE6-553E68BD23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4E353B-6FAA-41A0-9677-81D242CA94D0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F1D2B62-ED85-6BC0-AB04-C81613483E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61D406-A0F3-FA15-F726-5C8EF6A46A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CAD7AD-0B9D-4B31-AA14-A6AB9F97C39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456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2" name="Groupe 71">
            <a:extLst>
              <a:ext uri="{FF2B5EF4-FFF2-40B4-BE49-F238E27FC236}">
                <a16:creationId xmlns:a16="http://schemas.microsoft.com/office/drawing/2014/main" id="{AE967B01-87C2-8BD7-2C30-5358CEB94D1D}"/>
              </a:ext>
            </a:extLst>
          </p:cNvPr>
          <p:cNvGrpSpPr/>
          <p:nvPr/>
        </p:nvGrpSpPr>
        <p:grpSpPr>
          <a:xfrm>
            <a:off x="455459" y="804998"/>
            <a:ext cx="2903507" cy="5314718"/>
            <a:chOff x="402707" y="620790"/>
            <a:chExt cx="2912891" cy="5561327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FBE84F71-6CFE-A105-627B-0182A7411153}"/>
                </a:ext>
              </a:extLst>
            </p:cNvPr>
            <p:cNvSpPr/>
            <p:nvPr/>
          </p:nvSpPr>
          <p:spPr>
            <a:xfrm>
              <a:off x="1814543" y="620790"/>
              <a:ext cx="1237463" cy="2656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 err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Z</a:t>
              </a:r>
              <a:r>
                <a:rPr lang="el-GR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050" b="1" baseline="-40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AR1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D7DEDD14-0E60-4008-901A-B2C6967960C6}"/>
                </a:ext>
              </a:extLst>
            </p:cNvPr>
            <p:cNvSpPr/>
            <p:nvPr/>
          </p:nvSpPr>
          <p:spPr>
            <a:xfrm>
              <a:off x="1070570" y="1902608"/>
              <a:ext cx="1919647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S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icroadriaticum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637E3CCF-67BD-3A9F-5BC4-3B48CA1B13AB}"/>
                </a:ext>
              </a:extLst>
            </p:cNvPr>
            <p:cNvSpPr/>
            <p:nvPr/>
          </p:nvSpPr>
          <p:spPr>
            <a:xfrm>
              <a:off x="1618792" y="1163049"/>
              <a:ext cx="1452510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M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usilla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28995F41-19A9-5523-D71E-1E10A3578148}"/>
                </a:ext>
              </a:extLst>
            </p:cNvPr>
            <p:cNvSpPr/>
            <p:nvPr/>
          </p:nvSpPr>
          <p:spPr>
            <a:xfrm>
              <a:off x="1433660" y="1282811"/>
              <a:ext cx="1610128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M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mmoda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791A5A46-0BEE-48CA-6F2B-F80D601689FE}"/>
                </a:ext>
              </a:extLst>
            </p:cNvPr>
            <p:cNvSpPr/>
            <p:nvPr/>
          </p:nvSpPr>
          <p:spPr>
            <a:xfrm>
              <a:off x="1753310" y="1408301"/>
              <a:ext cx="1317547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O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auri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FEF69B45-E5BF-1353-06B1-87FDCBCF1D08}"/>
                </a:ext>
              </a:extLst>
            </p:cNvPr>
            <p:cNvSpPr/>
            <p:nvPr/>
          </p:nvSpPr>
          <p:spPr>
            <a:xfrm>
              <a:off x="1409150" y="1531345"/>
              <a:ext cx="1681588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ovasolii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80778544-DFB8-B8ED-0273-75D7B45B0A57}"/>
                </a:ext>
              </a:extLst>
            </p:cNvPr>
            <p:cNvSpPr/>
            <p:nvPr/>
          </p:nvSpPr>
          <p:spPr>
            <a:xfrm>
              <a:off x="1623648" y="1657970"/>
              <a:ext cx="146484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oreaui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AAFCD36A-C8CA-8788-ED05-F35F266CBBE6}"/>
                </a:ext>
              </a:extLst>
            </p:cNvPr>
            <p:cNvSpPr/>
            <p:nvPr/>
          </p:nvSpPr>
          <p:spPr>
            <a:xfrm>
              <a:off x="1616809" y="1775323"/>
              <a:ext cx="146484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 goreaui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0700E658-26F8-DCE4-E68B-59CE8B62AEA8}"/>
                </a:ext>
              </a:extLst>
            </p:cNvPr>
            <p:cNvSpPr/>
            <p:nvPr/>
          </p:nvSpPr>
          <p:spPr>
            <a:xfrm>
              <a:off x="1431126" y="2382936"/>
              <a:ext cx="167085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LCPAC304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C2D0900D-2A90-8E2A-37C0-2259BBEF5203}"/>
                </a:ext>
              </a:extLst>
            </p:cNvPr>
            <p:cNvSpPr/>
            <p:nvPr/>
          </p:nvSpPr>
          <p:spPr>
            <a:xfrm>
              <a:off x="1435465" y="2501076"/>
              <a:ext cx="167085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LCPAC406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DC0CEE7A-3B5A-578E-5B8A-B5FBF9E0A77C}"/>
                </a:ext>
              </a:extLst>
            </p:cNvPr>
            <p:cNvSpPr/>
            <p:nvPr/>
          </p:nvSpPr>
          <p:spPr>
            <a:xfrm>
              <a:off x="657261" y="2625457"/>
              <a:ext cx="2510748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GVMAG-S-1025707-429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6B80B249-347C-C622-1F5F-DFD90F74EA4C}"/>
                </a:ext>
              </a:extLst>
            </p:cNvPr>
            <p:cNvSpPr/>
            <p:nvPr/>
          </p:nvSpPr>
          <p:spPr>
            <a:xfrm>
              <a:off x="651070" y="2749836"/>
              <a:ext cx="2526262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GVMAG-S-1025707-429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73434C23-A7C5-5412-E48C-B37983CD05C9}"/>
                </a:ext>
              </a:extLst>
            </p:cNvPr>
            <p:cNvSpPr/>
            <p:nvPr/>
          </p:nvSpPr>
          <p:spPr>
            <a:xfrm>
              <a:off x="463071" y="2873314"/>
              <a:ext cx="274460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10938_BIN245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484010C2-1BAF-963D-401C-DFA8C5CE9F86}"/>
                </a:ext>
              </a:extLst>
            </p:cNvPr>
            <p:cNvSpPr/>
            <p:nvPr/>
          </p:nvSpPr>
          <p:spPr>
            <a:xfrm>
              <a:off x="463639" y="2998643"/>
              <a:ext cx="274460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10938_BIN245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064C9232-3B9A-49A8-FF1F-F3CE51D75E47}"/>
                </a:ext>
              </a:extLst>
            </p:cNvPr>
            <p:cNvSpPr/>
            <p:nvPr/>
          </p:nvSpPr>
          <p:spPr>
            <a:xfrm>
              <a:off x="430103" y="3118353"/>
              <a:ext cx="274460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08255_BIN298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6B485F2E-412B-75FA-1216-E429B508FEA3}"/>
                </a:ext>
              </a:extLst>
            </p:cNvPr>
            <p:cNvSpPr/>
            <p:nvPr/>
          </p:nvSpPr>
          <p:spPr>
            <a:xfrm>
              <a:off x="1233707" y="3233307"/>
              <a:ext cx="1845594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AH6421103.1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1B951B1F-B67F-8D05-7DB7-259BFD7D5F79}"/>
                </a:ext>
              </a:extLst>
            </p:cNvPr>
            <p:cNvSpPr/>
            <p:nvPr/>
          </p:nvSpPr>
          <p:spPr>
            <a:xfrm>
              <a:off x="428222" y="3347521"/>
              <a:ext cx="274460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10938_BIN801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01FC8D59-22C2-1701-CADC-8086613F5ABA}"/>
                </a:ext>
              </a:extLst>
            </p:cNvPr>
            <p:cNvSpPr/>
            <p:nvPr/>
          </p:nvSpPr>
          <p:spPr>
            <a:xfrm>
              <a:off x="1017532" y="3467117"/>
              <a:ext cx="2046971" cy="2656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CA_003814225-1-Z</a:t>
              </a:r>
              <a:r>
                <a:rPr lang="el-GR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04305ACD-3FB6-93A2-2C35-E77873994B2E}"/>
                </a:ext>
              </a:extLst>
            </p:cNvPr>
            <p:cNvSpPr/>
            <p:nvPr/>
          </p:nvSpPr>
          <p:spPr>
            <a:xfrm>
              <a:off x="604017" y="3600064"/>
              <a:ext cx="2549394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06467_BIN4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A0B572CC-496A-6E02-760F-07677BB2DC23}"/>
                </a:ext>
              </a:extLst>
            </p:cNvPr>
            <p:cNvSpPr/>
            <p:nvPr/>
          </p:nvSpPr>
          <p:spPr>
            <a:xfrm>
              <a:off x="402707" y="3713924"/>
              <a:ext cx="2809173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14493_BIN257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A1BE8C39-C83F-DA2B-DAE1-6356F08568F6}"/>
                </a:ext>
              </a:extLst>
            </p:cNvPr>
            <p:cNvSpPr/>
            <p:nvPr/>
          </p:nvSpPr>
          <p:spPr>
            <a:xfrm>
              <a:off x="434485" y="3841475"/>
              <a:ext cx="2809173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GVMAG-M-3300005987-15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00E04392-D723-F1BE-BE56-06E8EEAD8108}"/>
                </a:ext>
              </a:extLst>
            </p:cNvPr>
            <p:cNvSpPr/>
            <p:nvPr/>
          </p:nvSpPr>
          <p:spPr>
            <a:xfrm>
              <a:off x="432370" y="3964581"/>
              <a:ext cx="2809173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GVMAG-M-3300005987-15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277C5651-51CF-DB7D-9659-B1D39B82DE6A}"/>
                </a:ext>
              </a:extLst>
            </p:cNvPr>
            <p:cNvSpPr/>
            <p:nvPr/>
          </p:nvSpPr>
          <p:spPr>
            <a:xfrm>
              <a:off x="624166" y="4074893"/>
              <a:ext cx="2497441" cy="2656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MGM3300021083_BIN1-Z</a:t>
              </a:r>
              <a:r>
                <a:rPr lang="el-GR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3561412C-A228-1913-0ABE-0A9D9F0BB3B4}"/>
                </a:ext>
              </a:extLst>
            </p:cNvPr>
            <p:cNvSpPr/>
            <p:nvPr/>
          </p:nvSpPr>
          <p:spPr>
            <a:xfrm>
              <a:off x="418857" y="4206052"/>
              <a:ext cx="2750244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GVMAG-M-3300020182-33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3B262671-A910-D53D-8BFC-33577ED7143D}"/>
                </a:ext>
              </a:extLst>
            </p:cNvPr>
            <p:cNvSpPr/>
            <p:nvPr/>
          </p:nvSpPr>
          <p:spPr>
            <a:xfrm>
              <a:off x="416718" y="4327934"/>
              <a:ext cx="2750244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19458_BIN240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DF652F62-5496-F83B-D195-32515744B7AE}"/>
                </a:ext>
              </a:extLst>
            </p:cNvPr>
            <p:cNvSpPr/>
            <p:nvPr/>
          </p:nvSpPr>
          <p:spPr>
            <a:xfrm>
              <a:off x="458475" y="4686635"/>
              <a:ext cx="2652960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37467_BIN618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F91F187B-6E22-710F-275F-409DF7079378}"/>
                </a:ext>
              </a:extLst>
            </p:cNvPr>
            <p:cNvSpPr/>
            <p:nvPr/>
          </p:nvSpPr>
          <p:spPr>
            <a:xfrm>
              <a:off x="411000" y="4575618"/>
              <a:ext cx="274460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42541_BIN490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6017AD7E-BAAB-80DC-7A79-6BBB43EB12FD}"/>
                </a:ext>
              </a:extLst>
            </p:cNvPr>
            <p:cNvSpPr/>
            <p:nvPr/>
          </p:nvSpPr>
          <p:spPr>
            <a:xfrm>
              <a:off x="416718" y="4453397"/>
              <a:ext cx="274460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42450_BIN843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BE3F2C82-C9E9-2BB1-54D8-F6EDD8C4211F}"/>
                </a:ext>
              </a:extLst>
            </p:cNvPr>
            <p:cNvSpPr/>
            <p:nvPr/>
          </p:nvSpPr>
          <p:spPr>
            <a:xfrm>
              <a:off x="410637" y="4822819"/>
              <a:ext cx="2744603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14838_BIN820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6625B662-F97B-637C-083E-83B0836ADD13}"/>
                </a:ext>
              </a:extLst>
            </p:cNvPr>
            <p:cNvSpPr/>
            <p:nvPr/>
          </p:nvSpPr>
          <p:spPr>
            <a:xfrm>
              <a:off x="426999" y="4941215"/>
              <a:ext cx="271278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23174_BIN273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F13B4FFB-87E0-921E-0F86-755D2A6EC374}"/>
                </a:ext>
              </a:extLst>
            </p:cNvPr>
            <p:cNvSpPr/>
            <p:nvPr/>
          </p:nvSpPr>
          <p:spPr>
            <a:xfrm>
              <a:off x="415916" y="5195008"/>
              <a:ext cx="274460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21079_BIN283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281DC2D7-6991-DF75-0AA3-82819986CF8D}"/>
                </a:ext>
              </a:extLst>
            </p:cNvPr>
            <p:cNvSpPr/>
            <p:nvPr/>
          </p:nvSpPr>
          <p:spPr>
            <a:xfrm>
              <a:off x="417109" y="5063575"/>
              <a:ext cx="274460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MGM3300009183_BIN399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7C59EA94-54F6-F90D-239D-08488D0DF0E6}"/>
                </a:ext>
              </a:extLst>
            </p:cNvPr>
            <p:cNvSpPr/>
            <p:nvPr/>
          </p:nvSpPr>
          <p:spPr>
            <a:xfrm>
              <a:off x="1782307" y="746815"/>
              <a:ext cx="1237463" cy="2656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 err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Z</a:t>
              </a:r>
              <a:r>
                <a:rPr lang="el-GR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050" b="1" baseline="-40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AR1</a:t>
              </a: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D6331D5A-2E2F-7F60-FECB-2C1081F3E6C7}"/>
                </a:ext>
              </a:extLst>
            </p:cNvPr>
            <p:cNvSpPr/>
            <p:nvPr/>
          </p:nvSpPr>
          <p:spPr>
            <a:xfrm>
              <a:off x="1632836" y="913866"/>
              <a:ext cx="1237463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enebrosa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AD2B2DBD-8663-58DC-BE5E-8CCA218F0EBF}"/>
                </a:ext>
              </a:extLst>
            </p:cNvPr>
            <p:cNvSpPr/>
            <p:nvPr/>
          </p:nvSpPr>
          <p:spPr>
            <a:xfrm>
              <a:off x="1662143" y="1039882"/>
              <a:ext cx="1237463" cy="2656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gitifera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-Z</a:t>
              </a:r>
              <a:r>
                <a:rPr lang="el-G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2C62C243-F365-E649-F484-6C1DDC9D9585}"/>
                </a:ext>
              </a:extLst>
            </p:cNvPr>
            <p:cNvSpPr/>
            <p:nvPr/>
          </p:nvSpPr>
          <p:spPr>
            <a:xfrm>
              <a:off x="1684436" y="2020752"/>
              <a:ext cx="1168279" cy="2656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fr-FR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FV-I73R</a:t>
              </a:r>
              <a:r>
                <a:rPr lang="en-US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Z</a:t>
              </a:r>
              <a:r>
                <a:rPr lang="el-GR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50" b="1" baseline="-40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03D3BA4B-321C-33BC-32D4-B22B4A128B89}"/>
                </a:ext>
              </a:extLst>
            </p:cNvPr>
            <p:cNvSpPr/>
            <p:nvPr/>
          </p:nvSpPr>
          <p:spPr>
            <a:xfrm>
              <a:off x="2289666" y="2132611"/>
              <a:ext cx="625905" cy="26569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sz="1050" b="1" dirty="0" err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vZ</a:t>
              </a:r>
              <a:r>
                <a:rPr lang="el-GR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050" b="1" baseline="-40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3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CE6BC839-5540-ADED-1053-802C19FABF43}"/>
                </a:ext>
              </a:extLst>
            </p:cNvPr>
            <p:cNvSpPr/>
            <p:nvPr/>
          </p:nvSpPr>
          <p:spPr>
            <a:xfrm>
              <a:off x="2021601" y="2265325"/>
              <a:ext cx="937892" cy="26569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HV3Z</a:t>
              </a:r>
              <a:r>
                <a:rPr lang="el-GR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050" b="1" baseline="-40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2</a:t>
              </a: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C7F750DA-5C1C-1EBC-F8BE-558D17CEA90B}"/>
                </a:ext>
              </a:extLst>
            </p:cNvPr>
            <p:cNvSpPr/>
            <p:nvPr/>
          </p:nvSpPr>
          <p:spPr>
            <a:xfrm>
              <a:off x="1583526" y="5313898"/>
              <a:ext cx="158702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b"/>
              <a:r>
                <a:rPr lang="fr-FR" sz="105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 </a:t>
              </a:r>
              <a:r>
                <a:rPr lang="fr-FR" sz="105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xtrinicus</a:t>
              </a:r>
              <a:r>
                <a:rPr lang="fr-FR" sz="105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105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r>
                <a:rPr lang="el-GR" sz="105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like</a:t>
              </a:r>
              <a:endParaRPr lang="en-US" sz="1050" b="1" baseline="-4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23A239D8-72D7-EA13-BB14-A8CEB45AAE01}"/>
                </a:ext>
              </a:extLst>
            </p:cNvPr>
            <p:cNvSpPr/>
            <p:nvPr/>
          </p:nvSpPr>
          <p:spPr>
            <a:xfrm>
              <a:off x="1728573" y="5440987"/>
              <a:ext cx="158702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b"/>
              <a:r>
                <a:rPr lang="fr-FR" sz="105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 </a:t>
              </a:r>
              <a:r>
                <a:rPr lang="fr-FR" sz="105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steurii</a:t>
              </a:r>
              <a:r>
                <a:rPr lang="fr-FR" sz="105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105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r>
                <a:rPr lang="el-GR" sz="105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like</a:t>
              </a:r>
              <a:endParaRPr lang="en-US" sz="1050" b="1" baseline="-4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75CA9459-E1A6-CC23-1FC7-CF74B852FEDF}"/>
                </a:ext>
              </a:extLst>
            </p:cNvPr>
            <p:cNvSpPr/>
            <p:nvPr/>
          </p:nvSpPr>
          <p:spPr>
            <a:xfrm>
              <a:off x="1704840" y="5561528"/>
              <a:ext cx="1433515" cy="2656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b"/>
              <a:r>
                <a:rPr lang="fr-F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 </a:t>
              </a:r>
              <a:r>
                <a:rPr lang="fr-FR" sz="1050" b="1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ohnsonii</a:t>
              </a:r>
              <a:r>
                <a:rPr lang="fr-F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r>
                <a:rPr lang="el-G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like</a:t>
              </a:r>
              <a:endParaRPr lang="en-US" sz="1050" b="1" baseline="-400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AE83C061-8CB8-5FBD-06DF-D437AEC1A7A3}"/>
                </a:ext>
              </a:extLst>
            </p:cNvPr>
            <p:cNvSpPr/>
            <p:nvPr/>
          </p:nvSpPr>
          <p:spPr>
            <a:xfrm>
              <a:off x="1571075" y="5790691"/>
              <a:ext cx="1589446" cy="2656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b"/>
              <a:r>
                <a:rPr lang="fr-F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 </a:t>
              </a:r>
              <a:r>
                <a:rPr lang="fr-FR" sz="1050" b="1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hamnosus</a:t>
              </a:r>
              <a:r>
                <a:rPr lang="fr-F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r>
                <a:rPr lang="el-G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like</a:t>
              </a:r>
              <a:endParaRPr lang="en-US" sz="1050" b="1" baseline="-400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6C3ACC41-351D-5B21-BA21-EBEA57D3F939}"/>
                </a:ext>
              </a:extLst>
            </p:cNvPr>
            <p:cNvSpPr/>
            <p:nvPr/>
          </p:nvSpPr>
          <p:spPr>
            <a:xfrm>
              <a:off x="1903510" y="5916419"/>
              <a:ext cx="1210070" cy="2656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b"/>
              <a:r>
                <a:rPr lang="fr-F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 </a:t>
              </a:r>
              <a:r>
                <a:rPr lang="fr-FR" sz="1050" b="1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rrae</a:t>
              </a:r>
              <a:r>
                <a:rPr lang="fr-F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r>
                <a:rPr lang="el-G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like</a:t>
              </a:r>
              <a:endParaRPr lang="en-US" sz="1050" b="1" baseline="-400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EFE626BB-F41A-5D17-0908-97F1829FD729}"/>
                </a:ext>
              </a:extLst>
            </p:cNvPr>
            <p:cNvSpPr/>
            <p:nvPr/>
          </p:nvSpPr>
          <p:spPr>
            <a:xfrm>
              <a:off x="1646805" y="5671625"/>
              <a:ext cx="1589446" cy="2656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b"/>
              <a:r>
                <a:rPr lang="fr-F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 </a:t>
              </a:r>
              <a:r>
                <a:rPr lang="fr-FR" sz="1050" b="1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lantarum</a:t>
              </a:r>
              <a:r>
                <a:rPr lang="fr-F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r>
                <a:rPr lang="el-G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FR" sz="105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like</a:t>
              </a:r>
              <a:endParaRPr lang="en-US" sz="1050" b="1" baseline="-400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89" name="Connecteur droit avec flèche 88">
            <a:extLst>
              <a:ext uri="{FF2B5EF4-FFF2-40B4-BE49-F238E27FC236}">
                <a16:creationId xmlns:a16="http://schemas.microsoft.com/office/drawing/2014/main" id="{32087723-928F-6173-A836-75F15D17D7BD}"/>
              </a:ext>
            </a:extLst>
          </p:cNvPr>
          <p:cNvCxnSpPr>
            <a:cxnSpLocks/>
          </p:cNvCxnSpPr>
          <p:nvPr/>
        </p:nvCxnSpPr>
        <p:spPr>
          <a:xfrm flipV="1">
            <a:off x="9145396" y="6050164"/>
            <a:ext cx="0" cy="144016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Connecteur droit avec flèche 89">
            <a:extLst>
              <a:ext uri="{FF2B5EF4-FFF2-40B4-BE49-F238E27FC236}">
                <a16:creationId xmlns:a16="http://schemas.microsoft.com/office/drawing/2014/main" id="{3FCE05F3-F596-EFF2-EA7B-05AE422496AD}"/>
              </a:ext>
            </a:extLst>
          </p:cNvPr>
          <p:cNvCxnSpPr>
            <a:cxnSpLocks/>
          </p:cNvCxnSpPr>
          <p:nvPr/>
        </p:nvCxnSpPr>
        <p:spPr>
          <a:xfrm flipV="1">
            <a:off x="9430169" y="6050164"/>
            <a:ext cx="0" cy="144016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Connecteur droit avec flèche 90">
            <a:extLst>
              <a:ext uri="{FF2B5EF4-FFF2-40B4-BE49-F238E27FC236}">
                <a16:creationId xmlns:a16="http://schemas.microsoft.com/office/drawing/2014/main" id="{F48E8799-FD9D-169A-1AD7-696D2BC7A88D}"/>
              </a:ext>
            </a:extLst>
          </p:cNvPr>
          <p:cNvCxnSpPr>
            <a:cxnSpLocks/>
          </p:cNvCxnSpPr>
          <p:nvPr/>
        </p:nvCxnSpPr>
        <p:spPr>
          <a:xfrm flipV="1">
            <a:off x="11028557" y="6047678"/>
            <a:ext cx="0" cy="144016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Connecteur droit avec flèche 91">
            <a:extLst>
              <a:ext uri="{FF2B5EF4-FFF2-40B4-BE49-F238E27FC236}">
                <a16:creationId xmlns:a16="http://schemas.microsoft.com/office/drawing/2014/main" id="{F4DC99A7-3DC1-1764-8FB5-84979ACF04BF}"/>
              </a:ext>
            </a:extLst>
          </p:cNvPr>
          <p:cNvCxnSpPr>
            <a:cxnSpLocks/>
          </p:cNvCxnSpPr>
          <p:nvPr/>
        </p:nvCxnSpPr>
        <p:spPr>
          <a:xfrm flipV="1">
            <a:off x="11176474" y="6047021"/>
            <a:ext cx="0" cy="144016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Connecteur droit avec flèche 92">
            <a:extLst>
              <a:ext uri="{FF2B5EF4-FFF2-40B4-BE49-F238E27FC236}">
                <a16:creationId xmlns:a16="http://schemas.microsoft.com/office/drawing/2014/main" id="{FFD038A5-16FA-A9D2-0429-692743FF2019}"/>
              </a:ext>
            </a:extLst>
          </p:cNvPr>
          <p:cNvCxnSpPr>
            <a:cxnSpLocks/>
          </p:cNvCxnSpPr>
          <p:nvPr/>
        </p:nvCxnSpPr>
        <p:spPr>
          <a:xfrm flipV="1">
            <a:off x="10948547" y="6047678"/>
            <a:ext cx="0" cy="144016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Rectangle 93">
            <a:extLst>
              <a:ext uri="{FF2B5EF4-FFF2-40B4-BE49-F238E27FC236}">
                <a16:creationId xmlns:a16="http://schemas.microsoft.com/office/drawing/2014/main" id="{FFD1C91A-F441-0232-2B6D-3341B898C839}"/>
              </a:ext>
            </a:extLst>
          </p:cNvPr>
          <p:cNvSpPr/>
          <p:nvPr/>
        </p:nvSpPr>
        <p:spPr>
          <a:xfrm>
            <a:off x="8652007" y="6106031"/>
            <a:ext cx="1272111" cy="2564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"/>
            <a:r>
              <a:rPr lang="en-US" sz="1600" b="1" baseline="-400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600" b="1" baseline="-40000" dirty="0" err="1">
                <a:latin typeface="Arial" panose="020B0604020202020204" pitchFamily="34" charset="0"/>
                <a:cs typeface="Arial" panose="020B0604020202020204" pitchFamily="34" charset="0"/>
              </a:rPr>
              <a:t>xxx</a:t>
            </a:r>
            <a:r>
              <a:rPr lang="en-US" sz="1600" b="1" baseline="-400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endParaRPr lang="en-US" sz="1600" b="1" baseline="-40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6ADB92C3-FF86-4DEB-8828-4DC6533CB653}"/>
              </a:ext>
            </a:extLst>
          </p:cNvPr>
          <p:cNvSpPr/>
          <p:nvPr/>
        </p:nvSpPr>
        <p:spPr>
          <a:xfrm>
            <a:off x="10463666" y="6090807"/>
            <a:ext cx="1272111" cy="2564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"/>
            <a:r>
              <a:rPr lang="en-US" sz="1600" b="1" baseline="-400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</a:t>
            </a:r>
            <a:r>
              <a:rPr lang="en-US" sz="1600" b="1" baseline="-40000" dirty="0" err="1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sz="1600" b="1" baseline="-400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lang="en-US" sz="1600" b="1" baseline="-40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ZoneTexte 95">
            <a:extLst>
              <a:ext uri="{FF2B5EF4-FFF2-40B4-BE49-F238E27FC236}">
                <a16:creationId xmlns:a16="http://schemas.microsoft.com/office/drawing/2014/main" id="{0C9314CB-48D2-C643-929B-3702AC9BBA0B}"/>
              </a:ext>
            </a:extLst>
          </p:cNvPr>
          <p:cNvSpPr txBox="1"/>
          <p:nvPr/>
        </p:nvSpPr>
        <p:spPr>
          <a:xfrm>
            <a:off x="1608846" y="6548844"/>
            <a:ext cx="22879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mentally confirmed </a:t>
            </a:r>
            <a:r>
              <a:rPr lang="en-US" sz="12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l-GR" sz="12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2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ZoneTexte 96">
            <a:extLst>
              <a:ext uri="{FF2B5EF4-FFF2-40B4-BE49-F238E27FC236}">
                <a16:creationId xmlns:a16="http://schemas.microsoft.com/office/drawing/2014/main" id="{0C096339-082A-802B-4D11-5F4F145988E7}"/>
              </a:ext>
            </a:extLst>
          </p:cNvPr>
          <p:cNvSpPr txBox="1"/>
          <p:nvPr/>
        </p:nvSpPr>
        <p:spPr>
          <a:xfrm>
            <a:off x="5852124" y="6548844"/>
            <a:ext cx="2474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mentally confirmed </a:t>
            </a:r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l-G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ke</a:t>
            </a:r>
          </a:p>
        </p:txBody>
      </p:sp>
      <p:sp>
        <p:nvSpPr>
          <p:cNvPr id="98" name="ZoneTexte 97">
            <a:extLst>
              <a:ext uri="{FF2B5EF4-FFF2-40B4-BE49-F238E27FC236}">
                <a16:creationId xmlns:a16="http://schemas.microsoft.com/office/drawing/2014/main" id="{A36BBAB6-532C-8AA7-9753-033D01A7903E}"/>
              </a:ext>
            </a:extLst>
          </p:cNvPr>
          <p:cNvSpPr txBox="1"/>
          <p:nvPr/>
        </p:nvSpPr>
        <p:spPr>
          <a:xfrm>
            <a:off x="8602326" y="6548844"/>
            <a:ext cx="18268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l-GR" sz="12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ke candidates</a:t>
            </a:r>
          </a:p>
        </p:txBody>
      </p:sp>
      <p:sp>
        <p:nvSpPr>
          <p:cNvPr id="99" name="ZoneTexte 98">
            <a:extLst>
              <a:ext uri="{FF2B5EF4-FFF2-40B4-BE49-F238E27FC236}">
                <a16:creationId xmlns:a16="http://schemas.microsoft.com/office/drawing/2014/main" id="{18CA5709-ECFC-CE9C-A58F-11CD9C3831D6}"/>
              </a:ext>
            </a:extLst>
          </p:cNvPr>
          <p:cNvSpPr txBox="1"/>
          <p:nvPr/>
        </p:nvSpPr>
        <p:spPr>
          <a:xfrm>
            <a:off x="3641008" y="6548844"/>
            <a:ext cx="25502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w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candidate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Connecteur droit 99">
            <a:extLst>
              <a:ext uri="{FF2B5EF4-FFF2-40B4-BE49-F238E27FC236}">
                <a16:creationId xmlns:a16="http://schemas.microsoft.com/office/drawing/2014/main" id="{8AE59561-2B39-FDB2-1925-9EEB53AC4219}"/>
              </a:ext>
            </a:extLst>
          </p:cNvPr>
          <p:cNvCxnSpPr/>
          <p:nvPr/>
        </p:nvCxnSpPr>
        <p:spPr>
          <a:xfrm>
            <a:off x="808650" y="2404685"/>
            <a:ext cx="0" cy="28762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ZoneTexte 101">
            <a:extLst>
              <a:ext uri="{FF2B5EF4-FFF2-40B4-BE49-F238E27FC236}">
                <a16:creationId xmlns:a16="http://schemas.microsoft.com/office/drawing/2014/main" id="{DB9AF62D-798F-325C-6313-FC9DFE623D67}"/>
              </a:ext>
            </a:extLst>
          </p:cNvPr>
          <p:cNvSpPr txBox="1"/>
          <p:nvPr/>
        </p:nvSpPr>
        <p:spPr>
          <a:xfrm>
            <a:off x="-51379" y="3684785"/>
            <a:ext cx="8874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ral</a:t>
            </a:r>
          </a:p>
        </p:txBody>
      </p:sp>
      <p:cxnSp>
        <p:nvCxnSpPr>
          <p:cNvPr id="103" name="Connecteur droit 102">
            <a:extLst>
              <a:ext uri="{FF2B5EF4-FFF2-40B4-BE49-F238E27FC236}">
                <a16:creationId xmlns:a16="http://schemas.microsoft.com/office/drawing/2014/main" id="{ED90CD56-ABA2-746D-5FF8-350603E82FA2}"/>
              </a:ext>
            </a:extLst>
          </p:cNvPr>
          <p:cNvCxnSpPr/>
          <p:nvPr/>
        </p:nvCxnSpPr>
        <p:spPr>
          <a:xfrm>
            <a:off x="1275375" y="1901035"/>
            <a:ext cx="0" cy="32121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ZoneTexte 105">
            <a:extLst>
              <a:ext uri="{FF2B5EF4-FFF2-40B4-BE49-F238E27FC236}">
                <a16:creationId xmlns:a16="http://schemas.microsoft.com/office/drawing/2014/main" id="{7D715DE9-344C-803C-C4A9-254E341721E2}"/>
              </a:ext>
            </a:extLst>
          </p:cNvPr>
          <p:cNvSpPr txBox="1"/>
          <p:nvPr/>
        </p:nvSpPr>
        <p:spPr>
          <a:xfrm>
            <a:off x="-51379" y="1901917"/>
            <a:ext cx="168475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BE" sz="1100" b="1" i="0" dirty="0" err="1">
                <a:solidFill>
                  <a:srgbClr val="00B0F0"/>
                </a:solidFill>
                <a:effectLst/>
                <a:latin typeface="Arial" panose="020B0604020202020204" pitchFamily="34" charset="0"/>
              </a:rPr>
              <a:t>Symbiodiniaceae</a:t>
            </a:r>
            <a:endParaRPr lang="en-US" sz="1100" b="1" dirty="0">
              <a:solidFill>
                <a:srgbClr val="00B0F0"/>
              </a:solidFill>
            </a:endParaRPr>
          </a:p>
        </p:txBody>
      </p:sp>
      <p:sp>
        <p:nvSpPr>
          <p:cNvPr id="107" name="ZoneTexte 106">
            <a:extLst>
              <a:ext uri="{FF2B5EF4-FFF2-40B4-BE49-F238E27FC236}">
                <a16:creationId xmlns:a16="http://schemas.microsoft.com/office/drawing/2014/main" id="{800B85F1-BCF7-FC59-00B6-DF06A771C8DA}"/>
              </a:ext>
            </a:extLst>
          </p:cNvPr>
          <p:cNvSpPr txBox="1"/>
          <p:nvPr/>
        </p:nvSpPr>
        <p:spPr>
          <a:xfrm>
            <a:off x="-51379" y="1511301"/>
            <a:ext cx="118645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BE" sz="1100" b="1" i="0" dirty="0" err="1">
                <a:solidFill>
                  <a:srgbClr val="00B0F0"/>
                </a:solidFill>
                <a:effectLst/>
                <a:latin typeface="Arial" panose="020B0604020202020204" pitchFamily="34" charset="0"/>
              </a:rPr>
              <a:t>Phytoplankton</a:t>
            </a:r>
            <a:endParaRPr lang="en-US" sz="1100" b="1" dirty="0">
              <a:solidFill>
                <a:srgbClr val="00B0F0"/>
              </a:solidFill>
            </a:endParaRPr>
          </a:p>
        </p:txBody>
      </p:sp>
      <p:cxnSp>
        <p:nvCxnSpPr>
          <p:cNvPr id="108" name="Connecteur droit 107">
            <a:extLst>
              <a:ext uri="{FF2B5EF4-FFF2-40B4-BE49-F238E27FC236}">
                <a16:creationId xmlns:a16="http://schemas.microsoft.com/office/drawing/2014/main" id="{5E0CB608-112B-32C1-A0EE-B3E31CA284AD}"/>
              </a:ext>
            </a:extLst>
          </p:cNvPr>
          <p:cNvCxnSpPr/>
          <p:nvPr/>
        </p:nvCxnSpPr>
        <p:spPr>
          <a:xfrm>
            <a:off x="1275375" y="1437299"/>
            <a:ext cx="0" cy="35333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ZoneTexte 108">
            <a:extLst>
              <a:ext uri="{FF2B5EF4-FFF2-40B4-BE49-F238E27FC236}">
                <a16:creationId xmlns:a16="http://schemas.microsoft.com/office/drawing/2014/main" id="{37FC3E8E-5C5D-E3BF-B2BB-985055688A91}"/>
              </a:ext>
            </a:extLst>
          </p:cNvPr>
          <p:cNvSpPr txBox="1"/>
          <p:nvPr/>
        </p:nvSpPr>
        <p:spPr>
          <a:xfrm>
            <a:off x="-51379" y="5653604"/>
            <a:ext cx="82259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BE" sz="1100" b="1" i="0" dirty="0" err="1">
                <a:solidFill>
                  <a:srgbClr val="00B0F0"/>
                </a:solidFill>
                <a:effectLst/>
                <a:latin typeface="Arial" panose="020B0604020202020204" pitchFamily="34" charset="0"/>
              </a:rPr>
              <a:t>Bacteria</a:t>
            </a:r>
            <a:endParaRPr lang="en-US" sz="1100" b="1" dirty="0">
              <a:solidFill>
                <a:srgbClr val="00B0F0"/>
              </a:solidFill>
            </a:endParaRPr>
          </a:p>
        </p:txBody>
      </p:sp>
      <p:cxnSp>
        <p:nvCxnSpPr>
          <p:cNvPr id="110" name="Connecteur droit 109">
            <a:extLst>
              <a:ext uri="{FF2B5EF4-FFF2-40B4-BE49-F238E27FC236}">
                <a16:creationId xmlns:a16="http://schemas.microsoft.com/office/drawing/2014/main" id="{76199BE5-41A8-2848-0B75-EEA6D01443E8}"/>
              </a:ext>
            </a:extLst>
          </p:cNvPr>
          <p:cNvCxnSpPr/>
          <p:nvPr/>
        </p:nvCxnSpPr>
        <p:spPr>
          <a:xfrm>
            <a:off x="808650" y="5434838"/>
            <a:ext cx="0" cy="62595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Connecteur droit 110">
            <a:extLst>
              <a:ext uri="{FF2B5EF4-FFF2-40B4-BE49-F238E27FC236}">
                <a16:creationId xmlns:a16="http://schemas.microsoft.com/office/drawing/2014/main" id="{72D97540-AFED-B222-9DAA-9082EFD6009A}"/>
              </a:ext>
            </a:extLst>
          </p:cNvPr>
          <p:cNvCxnSpPr/>
          <p:nvPr/>
        </p:nvCxnSpPr>
        <p:spPr>
          <a:xfrm>
            <a:off x="1275375" y="1171342"/>
            <a:ext cx="0" cy="19945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ZoneTexte 111">
            <a:extLst>
              <a:ext uri="{FF2B5EF4-FFF2-40B4-BE49-F238E27FC236}">
                <a16:creationId xmlns:a16="http://schemas.microsoft.com/office/drawing/2014/main" id="{AB49345D-CAD9-D256-6CA7-42FD68A2490A}"/>
              </a:ext>
            </a:extLst>
          </p:cNvPr>
          <p:cNvSpPr txBox="1"/>
          <p:nvPr/>
        </p:nvSpPr>
        <p:spPr>
          <a:xfrm>
            <a:off x="-51379" y="1153476"/>
            <a:ext cx="103817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hozoa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3073CE17-98BF-E873-6C17-56138849C06A}"/>
              </a:ext>
            </a:extLst>
          </p:cNvPr>
          <p:cNvSpPr txBox="1"/>
          <p:nvPr/>
        </p:nvSpPr>
        <p:spPr>
          <a:xfrm>
            <a:off x="71358" y="6564844"/>
            <a:ext cx="15942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lor code</a:t>
            </a:r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3507907E-4DF4-9F67-D720-D66604B73D33}"/>
              </a:ext>
            </a:extLst>
          </p:cNvPr>
          <p:cNvSpPr txBox="1"/>
          <p:nvPr/>
        </p:nvSpPr>
        <p:spPr>
          <a:xfrm>
            <a:off x="0" y="-32096"/>
            <a:ext cx="4083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1</a:t>
            </a:r>
          </a:p>
        </p:txBody>
      </p:sp>
      <p:pic>
        <p:nvPicPr>
          <p:cNvPr id="73" name="Image 72">
            <a:extLst>
              <a:ext uri="{FF2B5EF4-FFF2-40B4-BE49-F238E27FC236}">
                <a16:creationId xmlns:a16="http://schemas.microsoft.com/office/drawing/2014/main" id="{632DD026-8603-9A22-870B-0625D91C400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50" b="15511"/>
          <a:stretch/>
        </p:blipFill>
        <p:spPr>
          <a:xfrm>
            <a:off x="3051232" y="804998"/>
            <a:ext cx="9140768" cy="5251423"/>
          </a:xfrm>
          <a:prstGeom prst="rect">
            <a:avLst/>
          </a:prstGeom>
        </p:spPr>
      </p:pic>
      <p:sp>
        <p:nvSpPr>
          <p:cNvPr id="121" name="Rectangle 120">
            <a:extLst>
              <a:ext uri="{FF2B5EF4-FFF2-40B4-BE49-F238E27FC236}">
                <a16:creationId xmlns:a16="http://schemas.microsoft.com/office/drawing/2014/main" id="{A8A93941-AEAD-6CBB-63AC-B51C79DF57EE}"/>
              </a:ext>
            </a:extLst>
          </p:cNvPr>
          <p:cNvSpPr/>
          <p:nvPr/>
        </p:nvSpPr>
        <p:spPr>
          <a:xfrm>
            <a:off x="2059374" y="311781"/>
            <a:ext cx="904678" cy="253916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fontAlgn="b"/>
            <a:r>
              <a:rPr lang="en-US" sz="1050" b="1" dirty="0" err="1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Z</a:t>
            </a:r>
            <a:r>
              <a:rPr lang="el-GR" sz="1050" b="1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50" b="1" baseline="-40000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AR1</a:t>
            </a: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A2590DD9-25C6-B549-35DA-514FE1E4BE4E}"/>
              </a:ext>
            </a:extLst>
          </p:cNvPr>
          <p:cNvGrpSpPr/>
          <p:nvPr/>
        </p:nvGrpSpPr>
        <p:grpSpPr>
          <a:xfrm>
            <a:off x="3358966" y="30694"/>
            <a:ext cx="8398876" cy="812144"/>
            <a:chOff x="3358966" y="30694"/>
            <a:chExt cx="8398876" cy="812144"/>
          </a:xfrm>
        </p:grpSpPr>
        <p:pic>
          <p:nvPicPr>
            <p:cNvPr id="75" name="Image 74">
              <a:extLst>
                <a:ext uri="{FF2B5EF4-FFF2-40B4-BE49-F238E27FC236}">
                  <a16:creationId xmlns:a16="http://schemas.microsoft.com/office/drawing/2014/main" id="{3E670241-0B47-03FC-C927-91B4061F3D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-11282" r="78450" b="-1"/>
            <a:stretch/>
          </p:blipFill>
          <p:spPr>
            <a:xfrm>
              <a:off x="3633406" y="333739"/>
              <a:ext cx="1656184" cy="264083"/>
            </a:xfrm>
            <a:prstGeom prst="rect">
              <a:avLst/>
            </a:prstGeom>
          </p:spPr>
        </p:pic>
        <p:sp>
          <p:nvSpPr>
            <p:cNvPr id="76" name="ZoneTexte 75">
              <a:extLst>
                <a:ext uri="{FF2B5EF4-FFF2-40B4-BE49-F238E27FC236}">
                  <a16:creationId xmlns:a16="http://schemas.microsoft.com/office/drawing/2014/main" id="{1B3E85C6-87DF-319D-4E8C-CD9B812A8A44}"/>
                </a:ext>
              </a:extLst>
            </p:cNvPr>
            <p:cNvSpPr txBox="1"/>
            <p:nvPr/>
          </p:nvSpPr>
          <p:spPr>
            <a:xfrm>
              <a:off x="4543355" y="30694"/>
              <a:ext cx="6665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BE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Flèche : droite 76">
              <a:extLst>
                <a:ext uri="{FF2B5EF4-FFF2-40B4-BE49-F238E27FC236}">
                  <a16:creationId xmlns:a16="http://schemas.microsoft.com/office/drawing/2014/main" id="{2116FE38-9DE3-C1AD-CA9B-7058781ACA87}"/>
                </a:ext>
              </a:extLst>
            </p:cNvPr>
            <p:cNvSpPr/>
            <p:nvPr/>
          </p:nvSpPr>
          <p:spPr>
            <a:xfrm>
              <a:off x="6859675" y="421658"/>
              <a:ext cx="231424" cy="121363"/>
            </a:xfrm>
            <a:prstGeom prst="rightArrow">
              <a:avLst>
                <a:gd name="adj1" fmla="val 44047"/>
                <a:gd name="adj2" fmla="val 148853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78" name="Image 77">
              <a:extLst>
                <a:ext uri="{FF2B5EF4-FFF2-40B4-BE49-F238E27FC236}">
                  <a16:creationId xmlns:a16="http://schemas.microsoft.com/office/drawing/2014/main" id="{0C020136-622B-9E61-B2B3-2B5EF24311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-11282" r="78450" b="-1"/>
            <a:stretch/>
          </p:blipFill>
          <p:spPr>
            <a:xfrm>
              <a:off x="6547810" y="331099"/>
              <a:ext cx="1243598" cy="264083"/>
            </a:xfrm>
            <a:prstGeom prst="rect">
              <a:avLst/>
            </a:prstGeom>
          </p:spPr>
        </p:pic>
        <p:sp>
          <p:nvSpPr>
            <p:cNvPr id="101" name="ZoneTexte 100">
              <a:extLst>
                <a:ext uri="{FF2B5EF4-FFF2-40B4-BE49-F238E27FC236}">
                  <a16:creationId xmlns:a16="http://schemas.microsoft.com/office/drawing/2014/main" id="{A2B8A710-90E7-4C42-B596-3E94BEAAC4CE}"/>
                </a:ext>
              </a:extLst>
            </p:cNvPr>
            <p:cNvSpPr txBox="1"/>
            <p:nvPr/>
          </p:nvSpPr>
          <p:spPr>
            <a:xfrm>
              <a:off x="6679540" y="30694"/>
              <a:ext cx="6665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BE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ZoneTexte 103">
              <a:extLst>
                <a:ext uri="{FF2B5EF4-FFF2-40B4-BE49-F238E27FC236}">
                  <a16:creationId xmlns:a16="http://schemas.microsoft.com/office/drawing/2014/main" id="{507F2736-7E07-31D2-55A5-C1116ABA6416}"/>
                </a:ext>
              </a:extLst>
            </p:cNvPr>
            <p:cNvSpPr txBox="1"/>
            <p:nvPr/>
          </p:nvSpPr>
          <p:spPr>
            <a:xfrm>
              <a:off x="5998259" y="30694"/>
              <a:ext cx="6665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fr-BE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5" name="Image 104">
              <a:extLst>
                <a:ext uri="{FF2B5EF4-FFF2-40B4-BE49-F238E27FC236}">
                  <a16:creationId xmlns:a16="http://schemas.microsoft.com/office/drawing/2014/main" id="{E481A8D7-939D-48E9-79A1-9B25EF8C06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-11282" r="78450" b="-1"/>
            <a:stretch/>
          </p:blipFill>
          <p:spPr>
            <a:xfrm>
              <a:off x="8548650" y="320770"/>
              <a:ext cx="1322429" cy="264083"/>
            </a:xfrm>
            <a:prstGeom prst="rect">
              <a:avLst/>
            </a:prstGeom>
          </p:spPr>
        </p:pic>
        <p:sp>
          <p:nvSpPr>
            <p:cNvPr id="113" name="ZoneTexte 112">
              <a:extLst>
                <a:ext uri="{FF2B5EF4-FFF2-40B4-BE49-F238E27FC236}">
                  <a16:creationId xmlns:a16="http://schemas.microsoft.com/office/drawing/2014/main" id="{80594AAF-A4BC-74BD-8539-126D0AD06D77}"/>
                </a:ext>
              </a:extLst>
            </p:cNvPr>
            <p:cNvSpPr txBox="1"/>
            <p:nvPr/>
          </p:nvSpPr>
          <p:spPr>
            <a:xfrm>
              <a:off x="8991777" y="30694"/>
              <a:ext cx="6665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fr-BE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Flèche : droite 113">
              <a:extLst>
                <a:ext uri="{FF2B5EF4-FFF2-40B4-BE49-F238E27FC236}">
                  <a16:creationId xmlns:a16="http://schemas.microsoft.com/office/drawing/2014/main" id="{9590E8CC-5259-9FC9-25A8-7C66DEFD50CB}"/>
                </a:ext>
              </a:extLst>
            </p:cNvPr>
            <p:cNvSpPr/>
            <p:nvPr/>
          </p:nvSpPr>
          <p:spPr>
            <a:xfrm>
              <a:off x="10044721" y="426827"/>
              <a:ext cx="338828" cy="121363"/>
            </a:xfrm>
            <a:prstGeom prst="rightArrow">
              <a:avLst>
                <a:gd name="adj1" fmla="val 44047"/>
                <a:gd name="adj2" fmla="val 148853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5" name="ZoneTexte 114">
              <a:extLst>
                <a:ext uri="{FF2B5EF4-FFF2-40B4-BE49-F238E27FC236}">
                  <a16:creationId xmlns:a16="http://schemas.microsoft.com/office/drawing/2014/main" id="{71ED34EF-C30E-2EE3-24E2-13C70D874285}"/>
                </a:ext>
              </a:extLst>
            </p:cNvPr>
            <p:cNvSpPr txBox="1"/>
            <p:nvPr/>
          </p:nvSpPr>
          <p:spPr>
            <a:xfrm>
              <a:off x="9862123" y="30694"/>
              <a:ext cx="6665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fr-BE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Flèche : droite 115">
              <a:extLst>
                <a:ext uri="{FF2B5EF4-FFF2-40B4-BE49-F238E27FC236}">
                  <a16:creationId xmlns:a16="http://schemas.microsoft.com/office/drawing/2014/main" id="{A2306F41-DFA7-43C9-E9D6-4484A5E7FF2C}"/>
                </a:ext>
              </a:extLst>
            </p:cNvPr>
            <p:cNvSpPr/>
            <p:nvPr/>
          </p:nvSpPr>
          <p:spPr>
            <a:xfrm>
              <a:off x="10991657" y="443607"/>
              <a:ext cx="372711" cy="121363"/>
            </a:xfrm>
            <a:prstGeom prst="rightArrow">
              <a:avLst>
                <a:gd name="adj1" fmla="val 44047"/>
                <a:gd name="adj2" fmla="val 148853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7" name="ZoneTexte 116">
              <a:extLst>
                <a:ext uri="{FF2B5EF4-FFF2-40B4-BE49-F238E27FC236}">
                  <a16:creationId xmlns:a16="http://schemas.microsoft.com/office/drawing/2014/main" id="{DE5FAADD-CD07-05A0-B1C7-40F5BE780FC8}"/>
                </a:ext>
              </a:extLst>
            </p:cNvPr>
            <p:cNvSpPr txBox="1"/>
            <p:nvPr/>
          </p:nvSpPr>
          <p:spPr>
            <a:xfrm>
              <a:off x="10810505" y="30694"/>
              <a:ext cx="6665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fr-BE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ZoneTexte 117">
              <a:extLst>
                <a:ext uri="{FF2B5EF4-FFF2-40B4-BE49-F238E27FC236}">
                  <a16:creationId xmlns:a16="http://schemas.microsoft.com/office/drawing/2014/main" id="{036D44C1-E927-DFB6-7FD5-097BA5441B6A}"/>
                </a:ext>
              </a:extLst>
            </p:cNvPr>
            <p:cNvSpPr txBox="1"/>
            <p:nvPr/>
          </p:nvSpPr>
          <p:spPr>
            <a:xfrm>
              <a:off x="8783324" y="499116"/>
              <a:ext cx="7472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  <a:p>
              <a:pPr algn="ctr"/>
              <a:r>
                <a:rPr lang="en-US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173</a:t>
              </a:r>
            </a:p>
          </p:txBody>
        </p:sp>
        <p:sp>
          <p:nvSpPr>
            <p:cNvPr id="119" name="ZoneTexte 118">
              <a:extLst>
                <a:ext uri="{FF2B5EF4-FFF2-40B4-BE49-F238E27FC236}">
                  <a16:creationId xmlns:a16="http://schemas.microsoft.com/office/drawing/2014/main" id="{E329DE53-27CD-78A3-8FCA-A67798407B44}"/>
                </a:ext>
              </a:extLst>
            </p:cNvPr>
            <p:cNvSpPr txBox="1"/>
            <p:nvPr/>
          </p:nvSpPr>
          <p:spPr>
            <a:xfrm>
              <a:off x="9071739" y="504284"/>
              <a:ext cx="7472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  <a:p>
              <a:pPr algn="ctr"/>
              <a:r>
                <a:rPr lang="en-US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177</a:t>
              </a:r>
            </a:p>
          </p:txBody>
        </p:sp>
        <p:sp>
          <p:nvSpPr>
            <p:cNvPr id="120" name="ZoneTexte 119">
              <a:extLst>
                <a:ext uri="{FF2B5EF4-FFF2-40B4-BE49-F238E27FC236}">
                  <a16:creationId xmlns:a16="http://schemas.microsoft.com/office/drawing/2014/main" id="{96B5CE5E-2E4A-27C8-3822-D203E68F09EE}"/>
                </a:ext>
              </a:extLst>
            </p:cNvPr>
            <p:cNvSpPr txBox="1"/>
            <p:nvPr/>
          </p:nvSpPr>
          <p:spPr>
            <a:xfrm>
              <a:off x="10793186" y="501704"/>
              <a:ext cx="7472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  <a:p>
              <a:pPr algn="ctr"/>
              <a:r>
                <a:rPr lang="en-US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195</a:t>
              </a:r>
            </a:p>
          </p:txBody>
        </p:sp>
        <p:cxnSp>
          <p:nvCxnSpPr>
            <p:cNvPr id="122" name="Connecteur droit 121">
              <a:extLst>
                <a:ext uri="{FF2B5EF4-FFF2-40B4-BE49-F238E27FC236}">
                  <a16:creationId xmlns:a16="http://schemas.microsoft.com/office/drawing/2014/main" id="{7DE05D0A-8A1B-04EE-41D3-34F453624A50}"/>
                </a:ext>
              </a:extLst>
            </p:cNvPr>
            <p:cNvCxnSpPr>
              <a:cxnSpLocks/>
            </p:cNvCxnSpPr>
            <p:nvPr/>
          </p:nvCxnSpPr>
          <p:spPr>
            <a:xfrm>
              <a:off x="3358966" y="499116"/>
              <a:ext cx="8398876" cy="0"/>
            </a:xfrm>
            <a:prstGeom prst="line">
              <a:avLst/>
            </a:prstGeom>
            <a:ln w="57150">
              <a:solidFill>
                <a:schemeClr val="accent2">
                  <a:lumMod val="75000"/>
                  <a:alpha val="50196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Flèche : droite 122">
              <a:extLst>
                <a:ext uri="{FF2B5EF4-FFF2-40B4-BE49-F238E27FC236}">
                  <a16:creationId xmlns:a16="http://schemas.microsoft.com/office/drawing/2014/main" id="{234CEE27-639B-023C-E56F-405C72DF3B00}"/>
                </a:ext>
              </a:extLst>
            </p:cNvPr>
            <p:cNvSpPr/>
            <p:nvPr/>
          </p:nvSpPr>
          <p:spPr>
            <a:xfrm>
              <a:off x="6286377" y="435619"/>
              <a:ext cx="254566" cy="121363"/>
            </a:xfrm>
            <a:prstGeom prst="rightArrow">
              <a:avLst>
                <a:gd name="adj1" fmla="val 44047"/>
                <a:gd name="adj2" fmla="val 148853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6525323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74;p16">
            <a:extLst>
              <a:ext uri="{FF2B5EF4-FFF2-40B4-BE49-F238E27FC236}">
                <a16:creationId xmlns:a16="http://schemas.microsoft.com/office/drawing/2014/main" id="{EC7ECA2F-7DC2-870C-A14B-F773E2489D43}"/>
              </a:ext>
            </a:extLst>
          </p:cNvPr>
          <p:cNvSpPr txBox="1"/>
          <p:nvPr/>
        </p:nvSpPr>
        <p:spPr>
          <a:xfrm>
            <a:off x="4069873" y="952602"/>
            <a:ext cx="3755281" cy="49527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en" sz="1733" dirty="0">
                <a:solidFill>
                  <a:schemeClr val="dk1"/>
                </a:solidFill>
              </a:rPr>
              <a:t>3300042937	</a:t>
            </a:r>
            <a:r>
              <a:rPr lang="en" sz="1733" b="1" dirty="0">
                <a:solidFill>
                  <a:srgbClr val="9FC5E8"/>
                </a:solidFill>
              </a:rPr>
              <a:t>Freshwater</a:t>
            </a:r>
            <a:endParaRPr sz="1733" b="1" dirty="0">
              <a:solidFill>
                <a:srgbClr val="9FC5E8"/>
              </a:solidFill>
            </a:endParaRPr>
          </a:p>
          <a:p>
            <a:r>
              <a:rPr lang="en" sz="1733" dirty="0">
                <a:solidFill>
                  <a:schemeClr val="dk1"/>
                </a:solidFill>
              </a:rPr>
              <a:t>3300042907	</a:t>
            </a:r>
            <a:r>
              <a:rPr lang="en" sz="1733" b="1" dirty="0">
                <a:solidFill>
                  <a:srgbClr val="9FC5E8"/>
                </a:solidFill>
              </a:rPr>
              <a:t>Freshwater</a:t>
            </a:r>
            <a:endParaRPr sz="1733" b="1" dirty="0">
              <a:solidFill>
                <a:srgbClr val="9FC5E8"/>
              </a:solidFill>
            </a:endParaRPr>
          </a:p>
          <a:p>
            <a:r>
              <a:rPr lang="en" sz="1733" dirty="0">
                <a:solidFill>
                  <a:schemeClr val="dk1"/>
                </a:solidFill>
              </a:rPr>
              <a:t>3300006467	</a:t>
            </a:r>
            <a:r>
              <a:rPr lang="en" sz="1733" b="1" dirty="0">
                <a:solidFill>
                  <a:srgbClr val="6D9EEB"/>
                </a:solidFill>
              </a:rPr>
              <a:t>Marine</a:t>
            </a:r>
            <a:endParaRPr sz="1733" b="1" dirty="0">
              <a:solidFill>
                <a:srgbClr val="6D9EEB"/>
              </a:solidFill>
            </a:endParaRPr>
          </a:p>
          <a:p>
            <a:r>
              <a:rPr lang="en" sz="1733" dirty="0">
                <a:solidFill>
                  <a:schemeClr val="dk1"/>
                </a:solidFill>
              </a:rPr>
              <a:t>3300037467	</a:t>
            </a:r>
            <a:r>
              <a:rPr lang="en" sz="1733" b="1" dirty="0">
                <a:solidFill>
                  <a:srgbClr val="B7B7B7"/>
                </a:solidFill>
              </a:rPr>
              <a:t>Defined media</a:t>
            </a:r>
            <a:endParaRPr sz="1733" b="1" dirty="0">
              <a:solidFill>
                <a:srgbClr val="B7B7B7"/>
              </a:solidFill>
            </a:endParaRPr>
          </a:p>
          <a:p>
            <a:r>
              <a:rPr lang="en" sz="1733" dirty="0">
                <a:solidFill>
                  <a:schemeClr val="dk1"/>
                </a:solidFill>
              </a:rPr>
              <a:t>3300005573	</a:t>
            </a:r>
            <a:r>
              <a:rPr lang="en" sz="1733" b="1" dirty="0">
                <a:solidFill>
                  <a:srgbClr val="D5A6BD"/>
                </a:solidFill>
              </a:rPr>
              <a:t>Thermal springs</a:t>
            </a:r>
            <a:endParaRPr sz="1733" b="1" dirty="0">
              <a:solidFill>
                <a:srgbClr val="D5A6BD"/>
              </a:solidFill>
            </a:endParaRPr>
          </a:p>
          <a:p>
            <a:r>
              <a:rPr lang="en" sz="1733" dirty="0">
                <a:solidFill>
                  <a:schemeClr val="dk1"/>
                </a:solidFill>
              </a:rPr>
              <a:t>3300021083	</a:t>
            </a:r>
            <a:r>
              <a:rPr lang="en" sz="1733" b="1" dirty="0">
                <a:solidFill>
                  <a:srgbClr val="E69138"/>
                </a:solidFill>
              </a:rPr>
              <a:t>Soil</a:t>
            </a:r>
            <a:endParaRPr sz="1733" b="1" dirty="0">
              <a:solidFill>
                <a:srgbClr val="E69138"/>
              </a:solidFill>
            </a:endParaRPr>
          </a:p>
          <a:p>
            <a:r>
              <a:rPr lang="en" sz="1733" dirty="0">
                <a:solidFill>
                  <a:schemeClr val="dk1"/>
                </a:solidFill>
              </a:rPr>
              <a:t>3300023174	</a:t>
            </a:r>
            <a:r>
              <a:rPr lang="en" sz="1733" b="1" dirty="0">
                <a:solidFill>
                  <a:srgbClr val="9FC5E8"/>
                </a:solidFill>
              </a:rPr>
              <a:t>Freshwater</a:t>
            </a:r>
            <a:endParaRPr sz="1733" b="1" dirty="0">
              <a:solidFill>
                <a:srgbClr val="9FC5E8"/>
              </a:solidFill>
            </a:endParaRPr>
          </a:p>
          <a:p>
            <a:r>
              <a:rPr lang="en" sz="1733" dirty="0">
                <a:solidFill>
                  <a:schemeClr val="dk1"/>
                </a:solidFill>
              </a:rPr>
              <a:t>3300014838	</a:t>
            </a:r>
            <a:r>
              <a:rPr lang="en" sz="1733" b="1" dirty="0">
                <a:solidFill>
                  <a:srgbClr val="E69138"/>
                </a:solidFill>
              </a:rPr>
              <a:t>Soil</a:t>
            </a:r>
            <a:endParaRPr sz="1733" b="1" dirty="0">
              <a:solidFill>
                <a:srgbClr val="E69138"/>
              </a:solidFill>
            </a:endParaRPr>
          </a:p>
          <a:p>
            <a:r>
              <a:rPr lang="en" sz="1733" dirty="0">
                <a:solidFill>
                  <a:schemeClr val="dk1"/>
                </a:solidFill>
              </a:rPr>
              <a:t>3300009183	</a:t>
            </a:r>
            <a:r>
              <a:rPr lang="en" sz="1733" b="1" dirty="0">
                <a:solidFill>
                  <a:srgbClr val="9FC5E8"/>
                </a:solidFill>
              </a:rPr>
              <a:t>Freshwater</a:t>
            </a:r>
            <a:endParaRPr sz="1733" b="1" dirty="0">
              <a:solidFill>
                <a:srgbClr val="9FC5E8"/>
              </a:solidFill>
            </a:endParaRPr>
          </a:p>
          <a:p>
            <a:r>
              <a:rPr lang="en" sz="1733" dirty="0">
                <a:solidFill>
                  <a:schemeClr val="dk1"/>
                </a:solidFill>
              </a:rPr>
              <a:t>3300021079	</a:t>
            </a:r>
            <a:r>
              <a:rPr lang="en" sz="1733" b="1" dirty="0">
                <a:solidFill>
                  <a:srgbClr val="9FC5E8"/>
                </a:solidFill>
              </a:rPr>
              <a:t>Freshwater</a:t>
            </a:r>
            <a:endParaRPr sz="1733" b="1" dirty="0">
              <a:solidFill>
                <a:srgbClr val="9FC5E8"/>
              </a:solidFill>
            </a:endParaRPr>
          </a:p>
          <a:p>
            <a:r>
              <a:rPr lang="en" sz="1733" dirty="0">
                <a:solidFill>
                  <a:schemeClr val="dk1"/>
                </a:solidFill>
              </a:rPr>
              <a:t>3300014493	</a:t>
            </a:r>
            <a:r>
              <a:rPr lang="en" sz="1733" b="1" dirty="0">
                <a:solidFill>
                  <a:srgbClr val="E69138"/>
                </a:solidFill>
              </a:rPr>
              <a:t>Soil</a:t>
            </a:r>
            <a:endParaRPr sz="1733" b="1" dirty="0">
              <a:solidFill>
                <a:srgbClr val="E69138"/>
              </a:solidFill>
            </a:endParaRPr>
          </a:p>
          <a:p>
            <a:r>
              <a:rPr lang="en" sz="1733" dirty="0">
                <a:solidFill>
                  <a:schemeClr val="dk1"/>
                </a:solidFill>
              </a:rPr>
              <a:t>3300010392	</a:t>
            </a:r>
            <a:r>
              <a:rPr lang="en" sz="1733" b="1" dirty="0">
                <a:solidFill>
                  <a:srgbClr val="6D9EEB"/>
                </a:solidFill>
              </a:rPr>
              <a:t>Marine</a:t>
            </a:r>
            <a:endParaRPr sz="1733" b="1" dirty="0">
              <a:solidFill>
                <a:srgbClr val="6D9EEB"/>
              </a:solidFill>
            </a:endParaRPr>
          </a:p>
          <a:p>
            <a:r>
              <a:rPr lang="en" sz="1733" dirty="0">
                <a:solidFill>
                  <a:schemeClr val="dk1"/>
                </a:solidFill>
              </a:rPr>
              <a:t>3300010430	</a:t>
            </a:r>
            <a:r>
              <a:rPr lang="en" sz="1733" b="1" dirty="0">
                <a:solidFill>
                  <a:srgbClr val="6D9EEB"/>
                </a:solidFill>
              </a:rPr>
              <a:t>Marine</a:t>
            </a:r>
            <a:endParaRPr sz="1733" b="1" dirty="0">
              <a:solidFill>
                <a:srgbClr val="6D9EEB"/>
              </a:solidFill>
            </a:endParaRPr>
          </a:p>
          <a:p>
            <a:r>
              <a:rPr lang="en" sz="1733" dirty="0">
                <a:solidFill>
                  <a:schemeClr val="dk1"/>
                </a:solidFill>
              </a:rPr>
              <a:t>3300010938	</a:t>
            </a:r>
            <a:r>
              <a:rPr lang="en" sz="1733" b="1" dirty="0">
                <a:solidFill>
                  <a:srgbClr val="D5A6BD"/>
                </a:solidFill>
              </a:rPr>
              <a:t>Thermal springs</a:t>
            </a:r>
            <a:endParaRPr sz="1733" b="1" dirty="0">
              <a:solidFill>
                <a:srgbClr val="D5A6BD"/>
              </a:solidFill>
            </a:endParaRPr>
          </a:p>
          <a:p>
            <a:r>
              <a:rPr lang="en" sz="1733" dirty="0"/>
              <a:t>3300042541	</a:t>
            </a:r>
            <a:r>
              <a:rPr lang="en" sz="1733" b="1" dirty="0">
                <a:solidFill>
                  <a:srgbClr val="9FC5E8"/>
                </a:solidFill>
              </a:rPr>
              <a:t>Freshwater</a:t>
            </a:r>
            <a:endParaRPr sz="1733" b="1" dirty="0">
              <a:solidFill>
                <a:srgbClr val="9FC5E8"/>
              </a:solidFill>
            </a:endParaRPr>
          </a:p>
          <a:p>
            <a:r>
              <a:rPr lang="en" sz="1733" dirty="0"/>
              <a:t>3300042450	</a:t>
            </a:r>
            <a:r>
              <a:rPr lang="en" sz="1733" b="1" dirty="0">
                <a:solidFill>
                  <a:srgbClr val="9FC5E8"/>
                </a:solidFill>
              </a:rPr>
              <a:t>Freshwater</a:t>
            </a:r>
            <a:endParaRPr sz="1733" b="1" dirty="0">
              <a:solidFill>
                <a:srgbClr val="9FC5E8"/>
              </a:solidFill>
            </a:endParaRPr>
          </a:p>
          <a:p>
            <a:r>
              <a:rPr lang="fr-BE" sz="2000" dirty="0"/>
              <a:t>003814225            </a:t>
            </a:r>
            <a:r>
              <a:rPr lang="fr-BE" sz="1730" b="1" dirty="0" err="1">
                <a:solidFill>
                  <a:srgbClr val="E69138"/>
                </a:solidFill>
              </a:rPr>
              <a:t>Soil</a:t>
            </a:r>
            <a:endParaRPr lang="fr-BE" sz="1730" b="1" dirty="0">
              <a:solidFill>
                <a:srgbClr val="E69138"/>
              </a:solidFill>
            </a:endParaRP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18F719EB-D5C2-5CE5-AA3C-35CE24BC9104}"/>
              </a:ext>
            </a:extLst>
          </p:cNvPr>
          <p:cNvSpPr txBox="1"/>
          <p:nvPr/>
        </p:nvSpPr>
        <p:spPr>
          <a:xfrm>
            <a:off x="0" y="-32096"/>
            <a:ext cx="4083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2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CFE87FB1-64C1-7748-3C6F-BDEC791F9706}"/>
              </a:ext>
            </a:extLst>
          </p:cNvPr>
          <p:cNvSpPr txBox="1"/>
          <p:nvPr/>
        </p:nvSpPr>
        <p:spPr>
          <a:xfrm>
            <a:off x="4175377" y="583270"/>
            <a:ext cx="11351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b="1" dirty="0"/>
              <a:t>NCLDV-ID</a:t>
            </a:r>
            <a:endParaRPr lang="en-US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AA065ED-0EC7-5D89-7A9B-AE5F08ED1630}"/>
              </a:ext>
            </a:extLst>
          </p:cNvPr>
          <p:cNvSpPr txBox="1"/>
          <p:nvPr/>
        </p:nvSpPr>
        <p:spPr>
          <a:xfrm>
            <a:off x="5840054" y="412579"/>
            <a:ext cx="19851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b="1" dirty="0">
                <a:solidFill>
                  <a:schemeClr val="dk1"/>
                </a:solidFill>
              </a:rPr>
              <a:t>Environmental distributi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06427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>
            <a:extLst>
              <a:ext uri="{FF2B5EF4-FFF2-40B4-BE49-F238E27FC236}">
                <a16:creationId xmlns:a16="http://schemas.microsoft.com/office/drawing/2014/main" id="{ED779880-7B29-FC0B-8F0D-736F79E3905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14" t="9370" r="6763" b="3022"/>
          <a:stretch/>
        </p:blipFill>
        <p:spPr>
          <a:xfrm>
            <a:off x="2950358" y="677008"/>
            <a:ext cx="5486401" cy="5683784"/>
          </a:xfrm>
          <a:prstGeom prst="rect">
            <a:avLst/>
          </a:prstGeom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A2DB1924-7FCF-368A-75A7-06F4204CC689}"/>
              </a:ext>
            </a:extLst>
          </p:cNvPr>
          <p:cNvSpPr txBox="1"/>
          <p:nvPr/>
        </p:nvSpPr>
        <p:spPr>
          <a:xfrm>
            <a:off x="1158324" y="4645114"/>
            <a:ext cx="168902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CA_003814225-1 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D9707A3D-BC74-4F78-DABE-B45F17F1158B}"/>
              </a:ext>
            </a:extLst>
          </p:cNvPr>
          <p:cNvSpPr txBox="1"/>
          <p:nvPr/>
        </p:nvSpPr>
        <p:spPr>
          <a:xfrm>
            <a:off x="1229855" y="5293285"/>
            <a:ext cx="161749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MGM3300021083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5D74A484-7698-BD10-30CB-A617DBA4EF0B}"/>
              </a:ext>
            </a:extLst>
          </p:cNvPr>
          <p:cNvSpPr txBox="1"/>
          <p:nvPr/>
        </p:nvSpPr>
        <p:spPr>
          <a:xfrm>
            <a:off x="469894" y="4981128"/>
            <a:ext cx="237745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VMAG-M-3300005987-15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90B4860-D17E-55D1-8177-A308BA5C8094}"/>
              </a:ext>
            </a:extLst>
          </p:cNvPr>
          <p:cNvSpPr txBox="1"/>
          <p:nvPr/>
        </p:nvSpPr>
        <p:spPr>
          <a:xfrm>
            <a:off x="864473" y="3730471"/>
            <a:ext cx="198287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VMAG-M-3300014838-63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AEF89849-32D3-5865-FC4B-8CF29DC14771}"/>
              </a:ext>
            </a:extLst>
          </p:cNvPr>
          <p:cNvSpPr txBox="1"/>
          <p:nvPr/>
        </p:nvSpPr>
        <p:spPr>
          <a:xfrm>
            <a:off x="920535" y="4040135"/>
            <a:ext cx="192681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VMAG-M-3300005987-15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BA4D60FC-237C-CD9D-3DC5-1E338C11D5FF}"/>
              </a:ext>
            </a:extLst>
          </p:cNvPr>
          <p:cNvSpPr txBox="1"/>
          <p:nvPr/>
        </p:nvSpPr>
        <p:spPr>
          <a:xfrm>
            <a:off x="469894" y="4377435"/>
            <a:ext cx="237745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MGM-3300008255_BIN298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DE227ABF-30E8-2821-1350-CDDB494DCF01}"/>
              </a:ext>
            </a:extLst>
          </p:cNvPr>
          <p:cNvSpPr txBox="1"/>
          <p:nvPr/>
        </p:nvSpPr>
        <p:spPr>
          <a:xfrm>
            <a:off x="1119157" y="803476"/>
            <a:ext cx="1728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fr-BE" sz="1100" b="1" i="1" u="none" strike="noStrike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fr-BE" sz="1100" b="1" i="1" u="none" strike="noStrike" dirty="0" err="1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nebrosa</a:t>
            </a:r>
            <a:endParaRPr lang="fr-BE" sz="1100" b="1" i="1" u="none" strike="noStrike" dirty="0">
              <a:solidFill>
                <a:srgbClr val="222222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27650079-BC72-A4CB-7D90-645715CD4224}"/>
              </a:ext>
            </a:extLst>
          </p:cNvPr>
          <p:cNvSpPr txBox="1"/>
          <p:nvPr/>
        </p:nvSpPr>
        <p:spPr>
          <a:xfrm>
            <a:off x="120151" y="822790"/>
            <a:ext cx="103817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1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hozoa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D232AF80-00C3-A30D-BD15-6F09992DAD3A}"/>
              </a:ext>
            </a:extLst>
          </p:cNvPr>
          <p:cNvSpPr txBox="1"/>
          <p:nvPr/>
        </p:nvSpPr>
        <p:spPr>
          <a:xfrm>
            <a:off x="120151" y="3718672"/>
            <a:ext cx="103817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1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CLDV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C544E23B-05A1-D6B1-3A8C-BE951F186E72}"/>
              </a:ext>
            </a:extLst>
          </p:cNvPr>
          <p:cNvSpPr txBox="1"/>
          <p:nvPr/>
        </p:nvSpPr>
        <p:spPr>
          <a:xfrm>
            <a:off x="1296357" y="2958823"/>
            <a:ext cx="15509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fr-BE" sz="1100" b="1" i="1" u="none" strike="noStrike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 </a:t>
            </a:r>
            <a:r>
              <a:rPr lang="fr-BE" sz="1100" b="1" i="1" u="none" strike="noStrike" dirty="0" err="1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icroadriaticum</a:t>
            </a:r>
            <a:r>
              <a:rPr lang="fr-BE" sz="1100" b="1" i="1" u="none" strike="noStrike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3E9F8507-228D-B77F-B1A8-B8CEDCD47FF9}"/>
              </a:ext>
            </a:extLst>
          </p:cNvPr>
          <p:cNvSpPr txBox="1"/>
          <p:nvPr/>
        </p:nvSpPr>
        <p:spPr>
          <a:xfrm>
            <a:off x="1229855" y="1851813"/>
            <a:ext cx="161749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fr-BE" sz="1100" b="1" i="1" u="none" strike="noStrike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  <a:r>
              <a:rPr lang="fr-BE" sz="1100" b="1" i="1" u="none" strike="noStrike" dirty="0" err="1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usilla</a:t>
            </a:r>
            <a:endParaRPr lang="en-US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5AD362D7-0C10-A3E9-F77C-4B61C684F58A}"/>
              </a:ext>
            </a:extLst>
          </p:cNvPr>
          <p:cNvSpPr txBox="1"/>
          <p:nvPr/>
        </p:nvSpPr>
        <p:spPr>
          <a:xfrm>
            <a:off x="994394" y="1441447"/>
            <a:ext cx="185295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fr-BE" sz="1100" b="1" i="1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  <a:r>
              <a:rPr lang="fr-BE" sz="1100" b="1" i="1" dirty="0" err="1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mmoda</a:t>
            </a:r>
            <a:endParaRPr lang="en-US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B9847029-7504-A10D-0F9B-F857ED1A7BE3}"/>
              </a:ext>
            </a:extLst>
          </p:cNvPr>
          <p:cNvSpPr txBox="1"/>
          <p:nvPr/>
        </p:nvSpPr>
        <p:spPr>
          <a:xfrm>
            <a:off x="1197118" y="2488441"/>
            <a:ext cx="165023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fr-BE" sz="1100" b="1" i="1" dirty="0" err="1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ladocopium</a:t>
            </a:r>
            <a:r>
              <a:rPr lang="fr-BE" sz="1100" b="1" i="1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goreaui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627AABDB-EC01-F60A-F6D1-04F2C3F16213}"/>
              </a:ext>
            </a:extLst>
          </p:cNvPr>
          <p:cNvSpPr txBox="1"/>
          <p:nvPr/>
        </p:nvSpPr>
        <p:spPr>
          <a:xfrm>
            <a:off x="88461" y="1444798"/>
            <a:ext cx="122170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BE" sz="1100" b="1" i="0" dirty="0" err="1">
                <a:solidFill>
                  <a:srgbClr val="00B0F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hytoplankton</a:t>
            </a:r>
            <a:endParaRPr lang="en-US" sz="1100" b="1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D08CA426-1C86-523B-6137-60AC5D2CD186}"/>
              </a:ext>
            </a:extLst>
          </p:cNvPr>
          <p:cNvSpPr txBox="1"/>
          <p:nvPr/>
        </p:nvSpPr>
        <p:spPr>
          <a:xfrm>
            <a:off x="1649808" y="6025506"/>
            <a:ext cx="119754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fr-BE" sz="1100" b="1" i="1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L </a:t>
            </a:r>
            <a:r>
              <a:rPr lang="fr-BE" sz="1100" b="1" i="1" u="none" strike="noStrike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xtrinicus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BD06E932-9607-9E15-C352-9348C5481607}"/>
              </a:ext>
            </a:extLst>
          </p:cNvPr>
          <p:cNvSpPr txBox="1"/>
          <p:nvPr/>
        </p:nvSpPr>
        <p:spPr>
          <a:xfrm>
            <a:off x="306509" y="6025506"/>
            <a:ext cx="81264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BE" sz="1100" b="1" i="0" dirty="0" err="1">
                <a:solidFill>
                  <a:srgbClr val="00B0F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acteria</a:t>
            </a:r>
            <a:endParaRPr lang="en-US" sz="1100" b="1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2CF4B134-8110-10B4-19E2-7D3FC7B4A6DD}"/>
              </a:ext>
            </a:extLst>
          </p:cNvPr>
          <p:cNvSpPr txBox="1"/>
          <p:nvPr/>
        </p:nvSpPr>
        <p:spPr>
          <a:xfrm>
            <a:off x="-76830" y="2499380"/>
            <a:ext cx="134428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BE" sz="1100" b="1" i="0" dirty="0" err="1">
                <a:solidFill>
                  <a:srgbClr val="00B0F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ymbiodiniaceae</a:t>
            </a:r>
            <a:endParaRPr lang="en-US" sz="1100" b="1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4B88B6BE-4758-E0E2-E296-852F12021244}"/>
              </a:ext>
            </a:extLst>
          </p:cNvPr>
          <p:cNvSpPr txBox="1"/>
          <p:nvPr/>
        </p:nvSpPr>
        <p:spPr>
          <a:xfrm>
            <a:off x="1658621" y="-33823"/>
            <a:ext cx="1425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ganism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E2C5B6EE-7D62-DFED-D154-8E02A54CBFE6}"/>
              </a:ext>
            </a:extLst>
          </p:cNvPr>
          <p:cNvSpPr txBox="1"/>
          <p:nvPr/>
        </p:nvSpPr>
        <p:spPr>
          <a:xfrm>
            <a:off x="4141176" y="-47739"/>
            <a:ext cx="22783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dicted domains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9788AB6A-9E35-4DEC-ECF3-46E41A9AF493}"/>
              </a:ext>
            </a:extLst>
          </p:cNvPr>
          <p:cNvSpPr txBox="1"/>
          <p:nvPr/>
        </p:nvSpPr>
        <p:spPr>
          <a:xfrm>
            <a:off x="8968148" y="-54697"/>
            <a:ext cx="2435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otation in PDBs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22D4EC37-EC00-825B-342A-5A697F0A63C8}"/>
              </a:ext>
            </a:extLst>
          </p:cNvPr>
          <p:cNvSpPr txBox="1"/>
          <p:nvPr/>
        </p:nvSpPr>
        <p:spPr>
          <a:xfrm>
            <a:off x="8680773" y="223184"/>
            <a:ext cx="1178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iprot</a:t>
            </a:r>
            <a:endParaRPr 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FDCDBE95-3025-CC59-7974-813A8E595B5B}"/>
              </a:ext>
            </a:extLst>
          </p:cNvPr>
          <p:cNvSpPr txBox="1"/>
          <p:nvPr/>
        </p:nvSpPr>
        <p:spPr>
          <a:xfrm>
            <a:off x="10582844" y="217323"/>
            <a:ext cx="1178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CBI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9EF72026-81DD-7281-3BD7-3100AFF5F55D}"/>
              </a:ext>
            </a:extLst>
          </p:cNvPr>
          <p:cNvSpPr txBox="1"/>
          <p:nvPr/>
        </p:nvSpPr>
        <p:spPr>
          <a:xfrm>
            <a:off x="8472899" y="6034218"/>
            <a:ext cx="184772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NA translocase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tsK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052AAD9D-F9DA-BCC4-4C92-E54B68DAAAF8}"/>
              </a:ext>
            </a:extLst>
          </p:cNvPr>
          <p:cNvSpPr txBox="1"/>
          <p:nvPr/>
        </p:nvSpPr>
        <p:spPr>
          <a:xfrm>
            <a:off x="10186058" y="5941886"/>
            <a:ext cx="221607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gma 54-interacting transcriptional regulator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386CC99B-CB44-AF55-439E-59EDF35427C6}"/>
              </a:ext>
            </a:extLst>
          </p:cNvPr>
          <p:cNvSpPr txBox="1"/>
          <p:nvPr/>
        </p:nvSpPr>
        <p:spPr>
          <a:xfrm>
            <a:off x="8584060" y="2945801"/>
            <a:ext cx="170904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fr-BE" sz="1200" b="1" i="0" dirty="0" err="1">
                <a:solidFill>
                  <a:srgbClr val="0A0A0A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cetate</a:t>
            </a:r>
            <a:r>
              <a:rPr lang="fr-BE" sz="1200" b="1" i="0" dirty="0">
                <a:solidFill>
                  <a:srgbClr val="0A0A0A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-CoA ligas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A12B90DA-F4B8-BCE2-9FDC-DFC1B99B208F}"/>
              </a:ext>
            </a:extLst>
          </p:cNvPr>
          <p:cNvSpPr txBox="1"/>
          <p:nvPr/>
        </p:nvSpPr>
        <p:spPr>
          <a:xfrm>
            <a:off x="10195983" y="2939942"/>
            <a:ext cx="170904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fr-BE" sz="1200" b="1" i="0" dirty="0" err="1">
                <a:solidFill>
                  <a:srgbClr val="0A0A0A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cetate</a:t>
            </a:r>
            <a:r>
              <a:rPr lang="fr-BE" sz="1200" b="1" i="0" dirty="0">
                <a:solidFill>
                  <a:srgbClr val="0A0A0A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-CoA ligas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B24D84C1-755B-5AD9-35AB-9DD9A4D5F458}"/>
              </a:ext>
            </a:extLst>
          </p:cNvPr>
          <p:cNvSpPr txBox="1"/>
          <p:nvPr/>
        </p:nvSpPr>
        <p:spPr>
          <a:xfrm>
            <a:off x="8680773" y="1495873"/>
            <a:ext cx="177522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BE" sz="1200" b="1" i="0" dirty="0">
                <a:solidFill>
                  <a:srgbClr val="0A0A0A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Z-binding </a:t>
            </a:r>
            <a:r>
              <a:rPr lang="fr-BE" sz="1200" b="1" i="0" dirty="0" err="1">
                <a:solidFill>
                  <a:srgbClr val="0A0A0A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omain-containing</a:t>
            </a:r>
            <a:r>
              <a:rPr lang="fr-BE" sz="1200" b="1" i="0" dirty="0">
                <a:solidFill>
                  <a:srgbClr val="0A0A0A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200" b="1" i="0" dirty="0" err="1">
                <a:solidFill>
                  <a:srgbClr val="0A0A0A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6E59CE34-AFF2-CB34-E76E-C676F704AA58}"/>
              </a:ext>
            </a:extLst>
          </p:cNvPr>
          <p:cNvSpPr txBox="1"/>
          <p:nvPr/>
        </p:nvSpPr>
        <p:spPr>
          <a:xfrm>
            <a:off x="10582844" y="1472224"/>
            <a:ext cx="133645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fr-BE" sz="1200" b="1" i="0" dirty="0" err="1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transcriptional</a:t>
            </a:r>
            <a:r>
              <a:rPr lang="fr-BE" sz="1200" b="1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BE" sz="1200" b="1" i="0" dirty="0" err="1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coactivator</a:t>
            </a:r>
            <a:r>
              <a:rPr lang="fr-BE" sz="1200" b="1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p15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17F0C751-A310-DC05-1974-6B6005CCCD4F}"/>
              </a:ext>
            </a:extLst>
          </p:cNvPr>
          <p:cNvSpPr txBox="1"/>
          <p:nvPr/>
        </p:nvSpPr>
        <p:spPr>
          <a:xfrm>
            <a:off x="10320623" y="592516"/>
            <a:ext cx="208150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ndoribonuclease Dicer 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D09ACA9A-83C8-CB3A-C28E-C2A56B0B5D73}"/>
              </a:ext>
            </a:extLst>
          </p:cNvPr>
          <p:cNvSpPr txBox="1"/>
          <p:nvPr/>
        </p:nvSpPr>
        <p:spPr>
          <a:xfrm>
            <a:off x="0" y="-32096"/>
            <a:ext cx="4083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3</a:t>
            </a:r>
          </a:p>
        </p:txBody>
      </p:sp>
    </p:spTree>
    <p:extLst>
      <p:ext uri="{BB962C8B-B14F-4D97-AF65-F5344CB8AC3E}">
        <p14:creationId xmlns:p14="http://schemas.microsoft.com/office/powerpoint/2010/main" val="63301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 descr="Une image contenant texte, diagramme, ligne, capture d’écran&#10;&#10;Description générée automatiquement">
            <a:extLst>
              <a:ext uri="{FF2B5EF4-FFF2-40B4-BE49-F238E27FC236}">
                <a16:creationId xmlns:a16="http://schemas.microsoft.com/office/drawing/2014/main" id="{FEE4FDB4-BBF0-5C7A-8C27-9FB8D51BC75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49" t="2476" r="802"/>
          <a:stretch/>
        </p:blipFill>
        <p:spPr>
          <a:xfrm>
            <a:off x="1017917" y="370936"/>
            <a:ext cx="11076317" cy="6116128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9C9B7BE3-E7A5-7225-7954-ECB9D753AD4F}"/>
              </a:ext>
            </a:extLst>
          </p:cNvPr>
          <p:cNvSpPr txBox="1"/>
          <p:nvPr/>
        </p:nvSpPr>
        <p:spPr>
          <a:xfrm>
            <a:off x="0" y="-32096"/>
            <a:ext cx="4083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S5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27985520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5</Words>
  <Application>Microsoft Office PowerPoint</Application>
  <PresentationFormat>Grand écran</PresentationFormat>
  <Paragraphs>121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9" baseType="lpstr">
      <vt:lpstr>Arial</vt:lpstr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MADOU diallo</dc:creator>
  <cp:lastModifiedBy>MAMADOU diallo</cp:lastModifiedBy>
  <cp:revision>36</cp:revision>
  <dcterms:created xsi:type="dcterms:W3CDTF">2023-09-07T07:11:20Z</dcterms:created>
  <dcterms:modified xsi:type="dcterms:W3CDTF">2024-06-14T16:25:15Z</dcterms:modified>
</cp:coreProperties>
</file>